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สไตล์สีปานกลาง 2 - เน้น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807A0F74-6745-538D-C901-DE39247168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A371D597-5DD6-4A0C-8C63-ABD4DC7537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3FA2E812-057F-BE99-D551-6E144B1AC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9BE2A162-17EF-A4FE-A524-3B4EC04A1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5F0B972-08DC-7840-C5F0-07A39FDA9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619358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7E2B4B33-0793-E484-AADA-34B973197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E213A530-A8B8-F56D-31B0-483802F58F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73AD04E9-DFA9-39FD-365D-C3A1E920B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2B13F923-0D1A-DB6E-A740-D22A2E25F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BF6DCD6-96C0-570E-C003-A657AF102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88495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5CAB99E0-3856-BFEF-2BF7-6241921FD5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0FC1A690-C221-2F98-EC9C-1B66EB6880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D01B335-318D-C854-F83A-62DB8C1E1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5AC9728-780B-DB60-331C-530741236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AEB25B86-0358-E068-13F2-3B4529F96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17760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916C5C0-1017-CA4A-1EE8-3734AADC30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C1E580F1-29D0-1B86-A792-BAA30C915F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ADBC84B-0A75-B0DA-3782-B6037D4CE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327343D-C497-E4D4-DC57-11D7A5786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0CF3BB3-5B0B-1B90-1B63-668D4A9AC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7051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0E2CCA3-DBCB-85F7-42F2-B0CB8EFC36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E3C69960-38B5-A4D8-D48B-FA9EFAF4CA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FE8A6C6-A331-521E-D8C5-D7BF78D5D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E8BB10FE-94FB-576A-E2CA-960828780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35A8424B-AA03-378A-CB9E-91AB5B0BE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0240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1AF0666-E725-ECD6-C089-53DA686B6D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A44E3A29-6175-BF5C-A1C2-326072228B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B0362614-2B56-9A09-889F-F7AC9D7542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8C8B85AB-5E15-5244-7CC6-3403D3222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91D3E944-DF5A-860E-F0A6-F6C9076F6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F7D83BF6-95FB-201E-B872-43F5A5994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55741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2AB76EFC-AA50-0270-FF87-95B3D99CB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C8028A1C-6984-1FFD-6E2C-ADBE65EDF0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3B2860E2-1029-BA9B-306A-1D7BE7103A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1333AF76-24F9-C7BC-9E15-10408FA492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30D913BF-72E5-E05C-8627-0FEA195C7D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1BAF16B8-F9E7-73D1-D490-FEA2C983A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39981D3E-AEB9-97B7-EE15-833E8F00D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A8DDB9FB-3640-4A2E-3F92-3D008ACFC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01095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E24B473-1BCA-B80B-566C-1A9889A0A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3D04D848-1250-6BEF-3D1B-610851F51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F4D406F3-38FF-B8E9-5F79-51DA1D045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90FBE26A-0913-503A-64A0-9E488CF6C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76692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C34AB735-610D-FFB8-4E3A-D0F65B6AE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70E79B34-56F1-437E-C9A1-61EC8F034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EC838E9E-5635-A545-064A-27EDF12C8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77673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622716A-892B-A27B-F903-66715B455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F28E8F66-0ADB-268C-596B-F197D606F1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61C35795-5E6F-0CD1-0EDD-B05C66F90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F2628450-9CE5-56B0-9902-D577DCA2D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A0423F23-13DD-78D1-8BE5-2DE5AB3A8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9F4AF05D-BDD1-7E17-B1B9-9285B8B81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66008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A2FCC872-8441-5561-18D8-84B9338A33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880FB23F-6489-A3B0-36EF-6F1AA495CD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0FC16C28-4E45-88CA-2C70-63EC7B5DDB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65D8604A-9604-92DB-1FC7-93830A19D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79590108-6044-24AA-54AD-90DF40551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90971E60-FD1E-C6E7-91AA-15B7145B4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50104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DD3B6CB6-B390-7CC8-F1C0-B715B2B58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061EEECA-74AE-A8B7-713C-E42705E5D1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5635577E-ABBF-58E7-AD4C-DE62E4064E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4855B-AFF0-4BD4-9AFC-5DE6CE7F166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74743D5D-82A1-7AA5-2EF7-DCD952F8D6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7CF047EB-7748-FFB9-EC43-71E2DA2EBB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48948-4242-4854-BAEE-774B283E25E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9976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B5A8E0F7-F980-0A98-DD47-D2D4ED040F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9207" y="2617151"/>
            <a:ext cx="6847932" cy="2653097"/>
          </a:xfrm>
          <a:prstGeom prst="rect">
            <a:avLst/>
          </a:prstGeom>
        </p:spPr>
      </p:pic>
      <p:sp>
        <p:nvSpPr>
          <p:cNvPr id="5" name="กล่องข้อความ 4">
            <a:extLst>
              <a:ext uri="{FF2B5EF4-FFF2-40B4-BE49-F238E27FC236}">
                <a16:creationId xmlns:a16="http://schemas.microsoft.com/office/drawing/2014/main" id="{67F24AC9-FA26-8C9E-D749-8EE4FC924A30}"/>
              </a:ext>
            </a:extLst>
          </p:cNvPr>
          <p:cNvSpPr txBox="1"/>
          <p:nvPr/>
        </p:nvSpPr>
        <p:spPr>
          <a:xfrm>
            <a:off x="1345720" y="1587752"/>
            <a:ext cx="10170543" cy="503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Table S1 Compounds identified in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serratum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(Linn.) Moon (CSM) drying with hot air oven via positive electrospray ionization (ESI+) LC-MS analysis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113109640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9:07Z</dcterms:created>
  <dcterms:modified xsi:type="dcterms:W3CDTF">2026-02-22T09:19:31Z</dcterms:modified>
</cp:coreProperties>
</file>